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9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194" autoAdjust="0"/>
  </p:normalViewPr>
  <p:slideViewPr>
    <p:cSldViewPr snapToGrid="0" snapToObjects="1" showGuides="1">
      <p:cViewPr>
        <p:scale>
          <a:sx n="99" d="100"/>
          <a:sy n="99" d="100"/>
        </p:scale>
        <p:origin x="-1304" y="-80"/>
      </p:cViewPr>
      <p:guideLst>
        <p:guide orient="horz" pos="2880"/>
        <p:guide pos="221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88" d="100"/>
        <a:sy n="188" d="100"/>
      </p:scale>
      <p:origin x="0" y="58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D2590C-021C-CE47-85CA-006D369F7FA3}" type="datetimeFigureOut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6C6187-154A-2844-B936-CEEB402319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859832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3DAC3B-6EC8-7C44-AD8C-223E71AC9B48}" type="datetimeFigureOut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88E33F-A977-B94E-A196-A6A0594E4A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773725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0CE65-6514-CB47-B134-E07529D2852D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285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CCFB-237F-2845-B5F1-792DD2EE8020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8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5E04B-180E-784E-A5DE-EA09220353E4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211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B54F0-669A-3543-B66E-ADD1AF86AD5C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69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0DA3A-1064-7A4E-AB21-EA2FD47FBD9D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845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E919B-F053-F040-A11E-DAA71844A73C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6957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71FAB-435B-E346-A109-1F37E583C929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558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6E142-966D-F847-95C7-C37FD305D179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332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34BBD-1CF7-7647-A97E-F17DD8868C4C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468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13D04-EA93-0944-B6C8-DB795AEE3BA8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3065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1CAF-C6CB-0B4E-953F-C4B3391DEBEE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982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7851D-2A90-FA4D-ACF9-CC0160D00ACE}" type="datetime1">
              <a:rPr kumimoji="1" lang="ja-JP" altLang="en-US" smtClean="0"/>
              <a:t>2017/04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72DD9-A316-2A43-8FBA-834EF3DA78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7501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066715" y="7096204"/>
            <a:ext cx="52259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"/>
                <a:cs typeface="Times"/>
              </a:rPr>
              <a:t>These simple main effect analyses were performed since there was a significant interaction in two-way repeated measures ANOVA. One-way ANOVA examined difference in changes of body weight between </a:t>
            </a:r>
            <a:r>
              <a:rPr lang="en-US" altLang="ja-JP" sz="1200" dirty="0">
                <a:latin typeface="Times"/>
                <a:cs typeface="Times"/>
              </a:rPr>
              <a:t>days (A) or </a:t>
            </a:r>
            <a:r>
              <a:rPr lang="en-US" altLang="ja-JP" sz="1200" dirty="0" smtClean="0">
                <a:latin typeface="Times"/>
                <a:cs typeface="Times"/>
              </a:rPr>
              <a:t>groups (</a:t>
            </a:r>
            <a:r>
              <a:rPr lang="en-US" altLang="ja-JP" sz="1200" dirty="0">
                <a:latin typeface="Times"/>
                <a:cs typeface="Times"/>
              </a:rPr>
              <a:t>B). </a:t>
            </a:r>
            <a:r>
              <a:rPr lang="en-US" altLang="ja-JP" sz="1200" dirty="0" smtClean="0">
                <a:latin typeface="Times"/>
                <a:cs typeface="Times"/>
              </a:rPr>
              <a:t>ND, non-defeated; D, defeated. 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951130" y="134644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"/>
                <a:cs typeface="Times"/>
              </a:rPr>
              <a:t>Group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783779" y="1704118"/>
            <a:ext cx="931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cs typeface="Times"/>
              </a:rPr>
              <a:t>ND + Water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783779" y="2002659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cs typeface="Times"/>
              </a:rPr>
              <a:t>D + Water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783779" y="2301201"/>
            <a:ext cx="955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"/>
                <a:cs typeface="Times"/>
              </a:rPr>
              <a:t>D + </a:t>
            </a:r>
            <a:r>
              <a:rPr kumimoji="1" lang="en-US" altLang="ja-JP" sz="1200" dirty="0" err="1" smtClean="0">
                <a:latin typeface="Times"/>
                <a:cs typeface="Times"/>
              </a:rPr>
              <a:t>kososan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497498" y="1346448"/>
            <a:ext cx="704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i="1" dirty="0" smtClean="0">
                <a:latin typeface="Times"/>
                <a:cs typeface="Times"/>
              </a:rPr>
              <a:t>F value</a:t>
            </a:r>
            <a:endParaRPr kumimoji="1" lang="ja-JP" altLang="en-US" sz="1200" b="1" i="1" dirty="0">
              <a:latin typeface="Times"/>
              <a:cs typeface="Times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149584" y="1346448"/>
            <a:ext cx="695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i="1" dirty="0">
                <a:latin typeface="Times"/>
                <a:cs typeface="Times"/>
              </a:rPr>
              <a:t>P</a:t>
            </a:r>
            <a:r>
              <a:rPr kumimoji="1" lang="en-US" altLang="ja-JP" sz="1200" b="1" i="1" dirty="0" smtClean="0">
                <a:latin typeface="Times"/>
                <a:cs typeface="Times"/>
              </a:rPr>
              <a:t> value</a:t>
            </a:r>
            <a:endParaRPr kumimoji="1" lang="ja-JP" altLang="en-US" sz="1200" b="1" i="1" dirty="0">
              <a:latin typeface="Times"/>
              <a:cs typeface="Times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341301" y="1704118"/>
            <a:ext cx="10884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11, 204) </a:t>
            </a:r>
            <a:r>
              <a:rPr kumimoji="1" lang="en-US" altLang="ja-JP" sz="1200" dirty="0" smtClean="0">
                <a:latin typeface="Times"/>
                <a:cs typeface="Times"/>
              </a:rPr>
              <a:t>= 6.36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341301" y="2002659"/>
            <a:ext cx="10884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11, 216) </a:t>
            </a:r>
            <a:r>
              <a:rPr kumimoji="1" lang="en-US" altLang="ja-JP" sz="1200" dirty="0" smtClean="0">
                <a:latin typeface="Times"/>
                <a:cs typeface="Times"/>
              </a:rPr>
              <a:t>= 24.2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341301" y="2301201"/>
            <a:ext cx="10884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11, 216) </a:t>
            </a:r>
            <a:r>
              <a:rPr kumimoji="1" lang="en-US" altLang="ja-JP" sz="1200" dirty="0" smtClean="0">
                <a:latin typeface="Times"/>
                <a:cs typeface="Times"/>
              </a:rPr>
              <a:t>= 15.2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083213" y="1704118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&lt; 0.001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084074" y="2001772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&lt; 0.001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084074" y="2279658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&lt; 0.001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034486" y="2803725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Times"/>
                <a:cs typeface="Times"/>
              </a:rPr>
              <a:t>Day 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130666" y="321735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1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130666" y="353133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2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341301" y="3531332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0.699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497498" y="2803725"/>
            <a:ext cx="704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i="1" dirty="0" smtClean="0">
                <a:latin typeface="Times"/>
                <a:cs typeface="Times"/>
              </a:rPr>
              <a:t>F value</a:t>
            </a:r>
            <a:endParaRPr kumimoji="1" lang="ja-JP" altLang="en-US" sz="1200" b="1" i="1" dirty="0">
              <a:latin typeface="Times"/>
              <a:cs typeface="Times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149584" y="2805981"/>
            <a:ext cx="695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i="1" dirty="0">
                <a:latin typeface="Times"/>
                <a:cs typeface="Times"/>
              </a:rPr>
              <a:t>P</a:t>
            </a:r>
            <a:r>
              <a:rPr kumimoji="1" lang="en-US" altLang="ja-JP" sz="1200" b="1" i="1" dirty="0" smtClean="0">
                <a:latin typeface="Times"/>
                <a:cs typeface="Times"/>
              </a:rPr>
              <a:t> value</a:t>
            </a:r>
            <a:endParaRPr kumimoji="1" lang="ja-JP" altLang="en-US" sz="1200" b="1" i="1" dirty="0">
              <a:latin typeface="Times"/>
              <a:cs typeface="Times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083213" y="3531332"/>
            <a:ext cx="827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502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130666" y="384531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3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341301" y="3845310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0.202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084074" y="3845310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818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130666" y="415928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4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341301" y="4159288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1.717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084074" y="4159288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189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130666" y="447326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5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341301" y="4473266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3.351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084074" y="4473266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043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130666" y="478724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6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341301" y="4787244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4.723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084074" y="4787244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013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130666" y="510122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7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341301" y="5101222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7.177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084074" y="5101222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002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130666" y="54152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8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341301" y="5415200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4.817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084074" y="5415200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012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130666" y="572917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9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341301" y="5729178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2.092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084074" y="5729178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134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092194" y="604315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10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341301" y="6043156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3.291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5084074" y="6043156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045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095012" y="6357134"/>
            <a:ext cx="332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11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341301" y="6357134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4.316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5084074" y="6357134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018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092194" y="667111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Times"/>
                <a:cs typeface="Times"/>
              </a:rPr>
              <a:t>12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341301" y="6671111"/>
            <a:ext cx="1066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>
                <a:latin typeface="Times"/>
                <a:cs typeface="Times"/>
              </a:rPr>
              <a:t>F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(2, </a:t>
            </a:r>
            <a:r>
              <a:rPr lang="en-US" altLang="ja-JP" sz="1200" baseline="-25000" dirty="0" smtClean="0">
                <a:latin typeface="Times"/>
                <a:cs typeface="Times"/>
              </a:rPr>
              <a:t>53</a:t>
            </a:r>
            <a:r>
              <a:rPr kumimoji="1" lang="en-US" altLang="ja-JP" sz="1200" baseline="-25000" dirty="0" smtClean="0">
                <a:latin typeface="Times"/>
                <a:cs typeface="Times"/>
              </a:rPr>
              <a:t>) </a:t>
            </a:r>
            <a:r>
              <a:rPr kumimoji="1" lang="en-US" altLang="ja-JP" sz="1200" dirty="0" smtClean="0">
                <a:latin typeface="Times"/>
                <a:cs typeface="Times"/>
              </a:rPr>
              <a:t>= 2.045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5084074" y="6671111"/>
            <a:ext cx="82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i="1" dirty="0" smtClean="0">
                <a:latin typeface="Times"/>
                <a:cs typeface="Times"/>
              </a:rPr>
              <a:t>p</a:t>
            </a:r>
            <a:r>
              <a:rPr lang="en-US" altLang="ja-JP" sz="1200" dirty="0" smtClean="0">
                <a:latin typeface="Times"/>
                <a:cs typeface="Times"/>
              </a:rPr>
              <a:t> = 0.140</a:t>
            </a:r>
            <a:endParaRPr kumimoji="1" lang="ja-JP" altLang="en-US" sz="1200" i="1" dirty="0">
              <a:latin typeface="Times"/>
              <a:cs typeface="Times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596092" y="3217354"/>
            <a:ext cx="532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 smtClean="0">
                <a:latin typeface="Times"/>
                <a:cs typeface="Times"/>
              </a:rPr>
              <a:t>-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5217992" y="3217354"/>
            <a:ext cx="532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 smtClean="0">
                <a:latin typeface="Times"/>
                <a:cs typeface="Times"/>
              </a:rPr>
              <a:t>-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222563" y="1423422"/>
            <a:ext cx="30862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"/>
                <a:cs typeface="Times"/>
              </a:rPr>
              <a:t>A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220651" y="2880699"/>
            <a:ext cx="287308" cy="27699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"/>
                <a:cs typeface="Times"/>
              </a:rPr>
              <a:t>B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cxnSp>
        <p:nvCxnSpPr>
          <p:cNvPr id="61" name="直線コネクタ 60"/>
          <p:cNvCxnSpPr/>
          <p:nvPr/>
        </p:nvCxnSpPr>
        <p:spPr>
          <a:xfrm>
            <a:off x="955760" y="1254174"/>
            <a:ext cx="5445254" cy="0"/>
          </a:xfrm>
          <a:prstGeom prst="line">
            <a:avLst/>
          </a:prstGeom>
          <a:ln w="38100" cmpd="dbl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955760" y="7071120"/>
            <a:ext cx="5445254" cy="12255"/>
          </a:xfrm>
          <a:prstGeom prst="line">
            <a:avLst/>
          </a:prstGeom>
          <a:ln w="38100" cmpd="dbl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>
            <a:off x="1801691" y="1687301"/>
            <a:ext cx="4161802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>
            <a:off x="1040796" y="2724914"/>
            <a:ext cx="5154975" cy="0"/>
          </a:xfrm>
          <a:prstGeom prst="line">
            <a:avLst/>
          </a:prstGeom>
          <a:ln w="12700" cmpd="sng">
            <a:solidFill>
              <a:srgbClr val="0000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/>
          <p:cNvSpPr txBox="1"/>
          <p:nvPr/>
        </p:nvSpPr>
        <p:spPr>
          <a:xfrm>
            <a:off x="880061" y="925373"/>
            <a:ext cx="5854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"/>
                <a:cs typeface="Times"/>
              </a:rPr>
              <a:t>Table S1</a:t>
            </a:r>
            <a:r>
              <a:rPr kumimoji="1" lang="en-US" altLang="ja-JP" sz="1200" dirty="0" smtClean="0">
                <a:latin typeface="Times"/>
                <a:cs typeface="Times"/>
              </a:rPr>
              <a:t> One –wa</a:t>
            </a:r>
            <a:r>
              <a:rPr lang="en-US" altLang="ja-JP" sz="1200" dirty="0" smtClean="0">
                <a:latin typeface="Times"/>
                <a:cs typeface="Times"/>
              </a:rPr>
              <a:t>y ANOVA analysis for </a:t>
            </a:r>
            <a:r>
              <a:rPr lang="en-US" altLang="ja-JP" sz="1200" dirty="0">
                <a:latin typeface="Times"/>
                <a:cs typeface="Times"/>
              </a:rPr>
              <a:t>s</a:t>
            </a:r>
            <a:r>
              <a:rPr kumimoji="1" lang="en-US" altLang="ja-JP" sz="1200" dirty="0" smtClean="0">
                <a:latin typeface="Times"/>
                <a:cs typeface="Times"/>
              </a:rPr>
              <a:t>imple main effects of changes in body weight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cxnSp>
        <p:nvCxnSpPr>
          <p:cNvPr id="65" name="直線コネクタ 64"/>
          <p:cNvCxnSpPr/>
          <p:nvPr/>
        </p:nvCxnSpPr>
        <p:spPr>
          <a:xfrm>
            <a:off x="1801691" y="3153209"/>
            <a:ext cx="4161802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5090412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9</TotalTime>
  <Words>258</Words>
  <Application>Microsoft Macintosh PowerPoint</Application>
  <PresentationFormat>画面に合わせる (4:3)</PresentationFormat>
  <Paragraphs>5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北里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 直樹</dc:creator>
  <cp:lastModifiedBy>伊藤 直樹</cp:lastModifiedBy>
  <cp:revision>331</cp:revision>
  <cp:lastPrinted>2017-02-08T00:34:03Z</cp:lastPrinted>
  <dcterms:created xsi:type="dcterms:W3CDTF">2015-11-06T08:17:15Z</dcterms:created>
  <dcterms:modified xsi:type="dcterms:W3CDTF">2017-04-03T08:13:32Z</dcterms:modified>
</cp:coreProperties>
</file>